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4"/>
  </p:notesMasterIdLst>
  <p:sldIdLst>
    <p:sldId id="261" r:id="rId2"/>
    <p:sldId id="271" r:id="rId3"/>
  </p:sldIdLst>
  <p:sldSz cx="77724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747775"/>
          </p15:clr>
        </p15:guide>
        <p15:guide id="2" pos="2448">
          <p15:clr>
            <a:srgbClr val="747775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C200788-D134-72D5-6D95-4C6ECCD29671}" name="Benjamin Miao" initials="BM" userId="S::bmiao5@jh.edu::5190ca18-df82-40b3-b3e3-a59479df070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3BFC4"/>
    <a:srgbClr val="7CAE00"/>
    <a:srgbClr val="F9776E"/>
    <a:srgbClr val="C87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489444D-A801-77B9-A4E5-5ABC0640CB92}" v="283" dt="2025-11-23T22:41:50.65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12"/>
  </p:normalViewPr>
  <p:slideViewPr>
    <p:cSldViewPr snapToGrid="0">
      <p:cViewPr varScale="1">
        <p:scale>
          <a:sx n="69" d="100"/>
          <a:sy n="69" d="100"/>
        </p:scale>
        <p:origin x="2431" y="6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04480" y="685800"/>
            <a:ext cx="2649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g38476bf4cad_0_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9538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5" name="Google Shape;125;g38476bf4cad_0_3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>
          <a:extLst>
            <a:ext uri="{FF2B5EF4-FFF2-40B4-BE49-F238E27FC236}">
              <a16:creationId xmlns:a16="http://schemas.microsoft.com/office/drawing/2014/main" id="{FE250C5D-D6A0-022D-F654-8D00E4C3B8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g38476bf4cad_0_121:notes">
            <a:extLst>
              <a:ext uri="{FF2B5EF4-FFF2-40B4-BE49-F238E27FC236}">
                <a16:creationId xmlns:a16="http://schemas.microsoft.com/office/drawing/2014/main" id="{6DE64938-5091-8C81-7BBE-CDD092612EBC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9538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7" name="Google Shape;137;g38476bf4cad_0_121:notes">
            <a:extLst>
              <a:ext uri="{FF2B5EF4-FFF2-40B4-BE49-F238E27FC236}">
                <a16:creationId xmlns:a16="http://schemas.microsoft.com/office/drawing/2014/main" id="{9EA4E70A-5AA9-C554-D99C-722E4D7A8865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667416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64945" y="4206107"/>
            <a:ext cx="7242600" cy="164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33999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107540" y="2253729"/>
            <a:ext cx="33999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64945" y="1086507"/>
            <a:ext cx="2386800" cy="1477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64945" y="2717440"/>
            <a:ext cx="2386800" cy="6217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16713" y="880293"/>
            <a:ext cx="5412600" cy="799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886200" y="-244"/>
            <a:ext cx="3886200" cy="100584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25675" y="2411542"/>
            <a:ext cx="3438300" cy="2898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25675" y="5481569"/>
            <a:ext cx="3438300" cy="24153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198575" y="1415969"/>
            <a:ext cx="3261600" cy="722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64945" y="8273124"/>
            <a:ext cx="5099100" cy="1183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64945" y="2163089"/>
            <a:ext cx="7242600" cy="3839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64945" y="6164351"/>
            <a:ext cx="7242600" cy="2543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18"/>
          <p:cNvSpPr txBox="1"/>
          <p:nvPr/>
        </p:nvSpPr>
        <p:spPr>
          <a:xfrm>
            <a:off x="-2420" y="461"/>
            <a:ext cx="7467600" cy="103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" sz="1800" dirty="0"/>
              <a:t>Supplemental Figure S1</a:t>
            </a:r>
            <a:endParaRPr sz="1800" dirty="0"/>
          </a:p>
        </p:txBody>
      </p:sp>
      <p:pic>
        <p:nvPicPr>
          <p:cNvPr id="128" name="Google Shape;128;p18" title="naive_single_cellplt_08292025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153754" y="512021"/>
            <a:ext cx="5413452" cy="3375285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2" name="Google Shape;80;p16">
            <a:extLst>
              <a:ext uri="{FF2B5EF4-FFF2-40B4-BE49-F238E27FC236}">
                <a16:creationId xmlns:a16="http://schemas.microsoft.com/office/drawing/2014/main" id="{5B0BF896-4C67-5E65-A576-8E1DAAFA542D}"/>
              </a:ext>
            </a:extLst>
          </p:cNvPr>
          <p:cNvGrpSpPr/>
          <p:nvPr/>
        </p:nvGrpSpPr>
        <p:grpSpPr>
          <a:xfrm>
            <a:off x="811052" y="6722968"/>
            <a:ext cx="5405195" cy="3128366"/>
            <a:chOff x="0" y="1074392"/>
            <a:chExt cx="4873774" cy="2625070"/>
          </a:xfrm>
        </p:grpSpPr>
        <p:pic>
          <p:nvPicPr>
            <p:cNvPr id="3" name="Google Shape;81;p16" title="TRUEPDAC_cell_prots_volc_08252025.jpg">
              <a:extLst>
                <a:ext uri="{FF2B5EF4-FFF2-40B4-BE49-F238E27FC236}">
                  <a16:creationId xmlns:a16="http://schemas.microsoft.com/office/drawing/2014/main" id="{767BB0FB-3C5C-91D8-B3F5-989370714DFB}"/>
                </a:ext>
              </a:extLst>
            </p:cNvPr>
            <p:cNvPicPr preferRelativeResize="0"/>
            <p:nvPr/>
          </p:nvPicPr>
          <p:blipFill>
            <a:blip r:embed="rId4">
              <a:alphaModFix/>
            </a:blip>
            <a:stretch>
              <a:fillRect/>
            </a:stretch>
          </p:blipFill>
          <p:spPr>
            <a:xfrm>
              <a:off x="2461016" y="1100135"/>
              <a:ext cx="2412758" cy="257359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" name="Google Shape;82;p16" title="TRUEPDAC_cells_genes_volc_bulk_08252025.jpg">
              <a:extLst>
                <a:ext uri="{FF2B5EF4-FFF2-40B4-BE49-F238E27FC236}">
                  <a16:creationId xmlns:a16="http://schemas.microsoft.com/office/drawing/2014/main" id="{8990CFAF-AD72-AD76-44E6-1E9F17CDA046}"/>
                </a:ext>
              </a:extLst>
            </p:cNvPr>
            <p:cNvPicPr preferRelativeResize="0"/>
            <p:nvPr/>
          </p:nvPicPr>
          <p:blipFill>
            <a:blip r:embed="rId5">
              <a:alphaModFix/>
            </a:blip>
            <a:stretch>
              <a:fillRect/>
            </a:stretch>
          </p:blipFill>
          <p:spPr>
            <a:xfrm>
              <a:off x="0" y="1074392"/>
              <a:ext cx="2461003" cy="262507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CF8A507F-8C4E-4FEA-A82E-97AE1C310D3E}"/>
              </a:ext>
            </a:extLst>
          </p:cNvPr>
          <p:cNvSpPr txBox="1"/>
          <p:nvPr/>
        </p:nvSpPr>
        <p:spPr>
          <a:xfrm>
            <a:off x="374410" y="6724385"/>
            <a:ext cx="3886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/>
              <a:t>C​</a:t>
            </a:r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8E2B00-C5BB-BC26-3631-C8E582EA776D}"/>
              </a:ext>
            </a:extLst>
          </p:cNvPr>
          <p:cNvSpPr txBox="1"/>
          <p:nvPr/>
        </p:nvSpPr>
        <p:spPr>
          <a:xfrm>
            <a:off x="1453894" y="3916117"/>
            <a:ext cx="3886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42FEB6-6E45-1063-DAB5-E3085FF3F7EE}"/>
              </a:ext>
            </a:extLst>
          </p:cNvPr>
          <p:cNvSpPr txBox="1"/>
          <p:nvPr/>
        </p:nvSpPr>
        <p:spPr>
          <a:xfrm>
            <a:off x="376037" y="653690"/>
            <a:ext cx="3886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/>
              <a:t>A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DA75691-991E-24E6-DA24-96626B20876E}"/>
              </a:ext>
            </a:extLst>
          </p:cNvPr>
          <p:cNvGrpSpPr/>
          <p:nvPr/>
        </p:nvGrpSpPr>
        <p:grpSpPr>
          <a:xfrm>
            <a:off x="1133892" y="3915510"/>
            <a:ext cx="4352353" cy="2659638"/>
            <a:chOff x="635291" y="1576844"/>
            <a:chExt cx="4877392" cy="3258170"/>
          </a:xfrm>
        </p:grpSpPr>
        <p:pic>
          <p:nvPicPr>
            <p:cNvPr id="10" name="Google Shape;134;p19" title="Bulk_omics_conserved_Heatmap_PDACgenes_08292025.jpg">
              <a:extLst>
                <a:ext uri="{FF2B5EF4-FFF2-40B4-BE49-F238E27FC236}">
                  <a16:creationId xmlns:a16="http://schemas.microsoft.com/office/drawing/2014/main" id="{4C296084-ADAE-C4C8-8332-54D668A43FB5}"/>
                </a:ext>
              </a:extLst>
            </p:cNvPr>
            <p:cNvPicPr preferRelativeResize="0"/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1809235" y="1576844"/>
              <a:ext cx="3626231" cy="297555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7FD2F8D-44E3-5282-23A5-AFC5122F6D0C}"/>
                </a:ext>
              </a:extLst>
            </p:cNvPr>
            <p:cNvSpPr txBox="1"/>
            <p:nvPr/>
          </p:nvSpPr>
          <p:spPr>
            <a:xfrm>
              <a:off x="894780" y="2175789"/>
              <a:ext cx="1544969" cy="4034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800"/>
                <a:t>Proteomic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DE82287-817C-DE59-DA07-2A694B583028}"/>
                </a:ext>
              </a:extLst>
            </p:cNvPr>
            <p:cNvSpPr txBox="1"/>
            <p:nvPr/>
          </p:nvSpPr>
          <p:spPr>
            <a:xfrm>
              <a:off x="1259221" y="3543128"/>
              <a:ext cx="1174833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800" err="1"/>
                <a:t>RNAseq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21C1E3E3-6E62-B286-5271-6D4AEEF55E26}"/>
                </a:ext>
              </a:extLst>
            </p:cNvPr>
            <p:cNvSpPr/>
            <p:nvPr/>
          </p:nvSpPr>
          <p:spPr>
            <a:xfrm>
              <a:off x="1722868" y="2688268"/>
              <a:ext cx="267341" cy="6237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BF31177-9921-D781-D37A-0FA024601F01}"/>
                </a:ext>
              </a:extLst>
            </p:cNvPr>
            <p:cNvSpPr txBox="1"/>
            <p:nvPr/>
          </p:nvSpPr>
          <p:spPr>
            <a:xfrm rot="16200000">
              <a:off x="66491" y="2771863"/>
              <a:ext cx="1537709" cy="40011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2000"/>
                <a:t>Methods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4B08AC6-53B5-FD54-85BE-4FD622D9BE50}"/>
                </a:ext>
              </a:extLst>
            </p:cNvPr>
            <p:cNvSpPr txBox="1"/>
            <p:nvPr/>
          </p:nvSpPr>
          <p:spPr>
            <a:xfrm>
              <a:off x="3228042" y="4434904"/>
              <a:ext cx="1537709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2000"/>
                <a:t>Genes</a:t>
              </a:r>
            </a:p>
          </p:txBody>
        </p:sp>
        <p:pic>
          <p:nvPicPr>
            <p:cNvPr id="16" name="Picture 15" descr="A red and white rectangle with black text&#10;&#10;AI-generated content may be incorrect.">
              <a:extLst>
                <a:ext uri="{FF2B5EF4-FFF2-40B4-BE49-F238E27FC236}">
                  <a16:creationId xmlns:a16="http://schemas.microsoft.com/office/drawing/2014/main" id="{09760828-DF13-F46F-0832-EEF3E6ABDBF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45781" y="2092385"/>
              <a:ext cx="466902" cy="1819695"/>
            </a:xfrm>
            <a:prstGeom prst="rect">
              <a:avLst/>
            </a:prstGeom>
          </p:spPr>
        </p:pic>
      </p:grpSp>
      <p:pic>
        <p:nvPicPr>
          <p:cNvPr id="9" name="Picture 8" descr="A list of cells with text&#10;&#10;AI-generated content may be incorrect.">
            <a:extLst>
              <a:ext uri="{FF2B5EF4-FFF2-40B4-BE49-F238E27FC236}">
                <a16:creationId xmlns:a16="http://schemas.microsoft.com/office/drawing/2014/main" id="{62A6A048-FBD2-3C29-4060-8BEF2A45E06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53613" y="769369"/>
            <a:ext cx="1518624" cy="285786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>
          <a:extLst>
            <a:ext uri="{FF2B5EF4-FFF2-40B4-BE49-F238E27FC236}">
              <a16:creationId xmlns:a16="http://schemas.microsoft.com/office/drawing/2014/main" id="{CC0EB227-ED2D-C5EB-5AB1-E35E72B3ED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20">
            <a:extLst>
              <a:ext uri="{FF2B5EF4-FFF2-40B4-BE49-F238E27FC236}">
                <a16:creationId xmlns:a16="http://schemas.microsoft.com/office/drawing/2014/main" id="{3FC1D0F9-495E-CB03-E07A-F2425B594B10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-555" y="1754"/>
            <a:ext cx="7226005" cy="63302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r>
              <a:rPr lang="en" dirty="0"/>
              <a:t>Supplemental Figure S2</a:t>
            </a:r>
            <a:endParaRPr dirty="0"/>
          </a:p>
        </p:txBody>
      </p:sp>
      <p:sp>
        <p:nvSpPr>
          <p:cNvPr id="11" name="Google Shape;163;p22">
            <a:extLst>
              <a:ext uri="{FF2B5EF4-FFF2-40B4-BE49-F238E27FC236}">
                <a16:creationId xmlns:a16="http://schemas.microsoft.com/office/drawing/2014/main" id="{4CADA822-0D88-C0DD-A223-3B0A6CD037FB}"/>
              </a:ext>
            </a:extLst>
          </p:cNvPr>
          <p:cNvSpPr txBox="1"/>
          <p:nvPr/>
        </p:nvSpPr>
        <p:spPr>
          <a:xfrm>
            <a:off x="826069" y="4586863"/>
            <a:ext cx="1265100" cy="26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TRIM29</a:t>
            </a:r>
            <a:endParaRPr sz="1800"/>
          </a:p>
        </p:txBody>
      </p:sp>
      <p:sp>
        <p:nvSpPr>
          <p:cNvPr id="13" name="Google Shape;164;p22">
            <a:extLst>
              <a:ext uri="{FF2B5EF4-FFF2-40B4-BE49-F238E27FC236}">
                <a16:creationId xmlns:a16="http://schemas.microsoft.com/office/drawing/2014/main" id="{F45CC25A-5765-B34F-F6DE-3B1BF0F639CB}"/>
              </a:ext>
            </a:extLst>
          </p:cNvPr>
          <p:cNvSpPr txBox="1"/>
          <p:nvPr/>
        </p:nvSpPr>
        <p:spPr>
          <a:xfrm>
            <a:off x="3336619" y="4586863"/>
            <a:ext cx="1265100" cy="26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MUC13</a:t>
            </a:r>
            <a:endParaRPr sz="1800"/>
          </a:p>
        </p:txBody>
      </p:sp>
      <p:sp>
        <p:nvSpPr>
          <p:cNvPr id="15" name="Google Shape;165;p22">
            <a:extLst>
              <a:ext uri="{FF2B5EF4-FFF2-40B4-BE49-F238E27FC236}">
                <a16:creationId xmlns:a16="http://schemas.microsoft.com/office/drawing/2014/main" id="{EE16BC4E-A40B-1F3E-B73A-D02095376920}"/>
              </a:ext>
            </a:extLst>
          </p:cNvPr>
          <p:cNvSpPr txBox="1"/>
          <p:nvPr/>
        </p:nvSpPr>
        <p:spPr>
          <a:xfrm>
            <a:off x="5910244" y="4586863"/>
            <a:ext cx="1265100" cy="26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KRT6A</a:t>
            </a:r>
            <a:endParaRPr sz="180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3BBF84-8D79-6F22-D22D-5C5E25FAA9E2}"/>
              </a:ext>
            </a:extLst>
          </p:cNvPr>
          <p:cNvSpPr txBox="1"/>
          <p:nvPr/>
        </p:nvSpPr>
        <p:spPr>
          <a:xfrm>
            <a:off x="83152" y="4485161"/>
            <a:ext cx="3886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dirty="0"/>
              <a:t>B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6636821-3C45-F5E8-4124-F5AAFAE2A971}"/>
              </a:ext>
            </a:extLst>
          </p:cNvPr>
          <p:cNvGrpSpPr/>
          <p:nvPr/>
        </p:nvGrpSpPr>
        <p:grpSpPr>
          <a:xfrm>
            <a:off x="1386448" y="846130"/>
            <a:ext cx="4815781" cy="2837810"/>
            <a:chOff x="6056" y="582362"/>
            <a:chExt cx="4094812" cy="265317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72257B5-7F55-2DB8-99BF-0644AB562D3C}"/>
                </a:ext>
              </a:extLst>
            </p:cNvPr>
            <p:cNvSpPr txBox="1"/>
            <p:nvPr/>
          </p:nvSpPr>
          <p:spPr>
            <a:xfrm>
              <a:off x="6056" y="582362"/>
              <a:ext cx="3886200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800"/>
                <a:t>A</a:t>
              </a:r>
            </a:p>
          </p:txBody>
        </p: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B04E8D42-0E1B-415E-B189-3E8EAB575000}"/>
                </a:ext>
              </a:extLst>
            </p:cNvPr>
            <p:cNvGrpSpPr/>
            <p:nvPr/>
          </p:nvGrpSpPr>
          <p:grpSpPr>
            <a:xfrm>
              <a:off x="157293" y="824494"/>
              <a:ext cx="1863704" cy="1288034"/>
              <a:chOff x="115109" y="856124"/>
              <a:chExt cx="2197811" cy="1595764"/>
            </a:xfrm>
          </p:grpSpPr>
          <p:pic>
            <p:nvPicPr>
              <p:cNvPr id="2" name="Picture 1" descr="A graph of a number of days&#10;&#10;AI-generated content may be incorrect.">
                <a:extLst>
                  <a:ext uri="{FF2B5EF4-FFF2-40B4-BE49-F238E27FC236}">
                    <a16:creationId xmlns:a16="http://schemas.microsoft.com/office/drawing/2014/main" id="{15BCF4EC-5D34-C6A2-FF32-22691B2205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5109" y="870869"/>
                <a:ext cx="2117148" cy="1581019"/>
              </a:xfrm>
              <a:prstGeom prst="rect">
                <a:avLst/>
              </a:prstGeom>
            </p:spPr>
          </p:pic>
          <p:sp>
            <p:nvSpPr>
              <p:cNvPr id="145" name="Google Shape;145;p20">
                <a:extLst>
                  <a:ext uri="{FF2B5EF4-FFF2-40B4-BE49-F238E27FC236}">
                    <a16:creationId xmlns:a16="http://schemas.microsoft.com/office/drawing/2014/main" id="{BF9023E8-F7B7-2746-B66B-3A5F138897F7}"/>
                  </a:ext>
                </a:extLst>
              </p:cNvPr>
              <p:cNvSpPr txBox="1"/>
              <p:nvPr/>
            </p:nvSpPr>
            <p:spPr>
              <a:xfrm>
                <a:off x="1216371" y="1224577"/>
                <a:ext cx="1016715" cy="1492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 sz="1200">
                    <a:solidFill>
                      <a:schemeClr val="dk2"/>
                    </a:solidFill>
                  </a:rPr>
                  <a:t>CFTR</a:t>
                </a:r>
                <a:endParaRPr sz="1200">
                  <a:solidFill>
                    <a:schemeClr val="dk2"/>
                  </a:solidFill>
                </a:endParaRP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8AED8D23-533B-DC22-6D63-6A037072E20D}"/>
                  </a:ext>
                </a:extLst>
              </p:cNvPr>
              <p:cNvGrpSpPr/>
              <p:nvPr/>
            </p:nvGrpSpPr>
            <p:grpSpPr>
              <a:xfrm>
                <a:off x="1297702" y="856124"/>
                <a:ext cx="285512" cy="184700"/>
                <a:chOff x="1297702" y="856124"/>
                <a:chExt cx="285512" cy="184700"/>
              </a:xfrm>
            </p:grpSpPr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5C2C0DC1-168D-2969-6DF9-55A3AB39732E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56897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A266F0FC-436D-18A0-41F3-4CDD9D2D11F8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/>
                    <a:t>27</a:t>
                  </a:r>
                </a:p>
              </p:txBody>
            </p: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3CD2D78-A35D-6F18-1C33-EDE38C621FD6}"/>
                  </a:ext>
                </a:extLst>
              </p:cNvPr>
              <p:cNvSpPr txBox="1"/>
              <p:nvPr/>
            </p:nvSpPr>
            <p:spPr>
              <a:xfrm>
                <a:off x="1221987" y="1198201"/>
                <a:ext cx="1090933" cy="307777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r>
                  <a:rPr lang="en-US"/>
                  <a:t>CFTR</a:t>
                </a:r>
              </a:p>
            </p:txBody>
          </p: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0BC0B3E6-2276-AF93-B6AB-DD660E8C35F5}"/>
                  </a:ext>
                </a:extLst>
              </p:cNvPr>
              <p:cNvGrpSpPr/>
              <p:nvPr/>
            </p:nvGrpSpPr>
            <p:grpSpPr>
              <a:xfrm>
                <a:off x="1740278" y="856157"/>
                <a:ext cx="285512" cy="184666"/>
                <a:chOff x="1271337" y="856158"/>
                <a:chExt cx="285512" cy="184666"/>
              </a:xfrm>
            </p:grpSpPr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92C9BA8D-A8E0-0F50-FFE3-515F80DFE6E0}"/>
                    </a:ext>
                  </a:extLst>
                </p:cNvPr>
                <p:cNvSpPr/>
                <p:nvPr/>
              </p:nvSpPr>
              <p:spPr>
                <a:xfrm>
                  <a:off x="1371215" y="887754"/>
                  <a:ext cx="62170" cy="1012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46501BEC-E8C1-E87E-F446-25F4A9BA8106}"/>
                    </a:ext>
                  </a:extLst>
                </p:cNvPr>
                <p:cNvSpPr txBox="1"/>
                <p:nvPr/>
              </p:nvSpPr>
              <p:spPr>
                <a:xfrm>
                  <a:off x="1271337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/>
                    <a:t>33</a:t>
                  </a:r>
                </a:p>
              </p:txBody>
            </p:sp>
          </p:grp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37B7AFE4-07F2-E179-95E2-8D2CA929A3F3}"/>
                </a:ext>
              </a:extLst>
            </p:cNvPr>
            <p:cNvGrpSpPr/>
            <p:nvPr/>
          </p:nvGrpSpPr>
          <p:grpSpPr>
            <a:xfrm>
              <a:off x="1912327" y="801673"/>
              <a:ext cx="1920837" cy="1281329"/>
              <a:chOff x="2077711" y="792863"/>
              <a:chExt cx="2263737" cy="1597852"/>
            </a:xfrm>
          </p:grpSpPr>
          <p:pic>
            <p:nvPicPr>
              <p:cNvPr id="10" name="Picture 9" descr="A graph of a number of days&#10;&#10;AI-generated content may be incorrect.">
                <a:extLst>
                  <a:ext uri="{FF2B5EF4-FFF2-40B4-BE49-F238E27FC236}">
                    <a16:creationId xmlns:a16="http://schemas.microsoft.com/office/drawing/2014/main" id="{A74FCEC5-EDCA-95FB-6897-129423D4A5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77711" y="809206"/>
                <a:ext cx="2263737" cy="1581509"/>
              </a:xfrm>
              <a:prstGeom prst="rect">
                <a:avLst/>
              </a:prstGeom>
            </p:spPr>
          </p:pic>
          <p:sp>
            <p:nvSpPr>
              <p:cNvPr id="146" name="Google Shape;146;p20">
                <a:extLst>
                  <a:ext uri="{FF2B5EF4-FFF2-40B4-BE49-F238E27FC236}">
                    <a16:creationId xmlns:a16="http://schemas.microsoft.com/office/drawing/2014/main" id="{99B6A9F4-92C6-381A-8685-DBF7C6AFDB23}"/>
                  </a:ext>
                </a:extLst>
              </p:cNvPr>
              <p:cNvSpPr txBox="1"/>
              <p:nvPr/>
            </p:nvSpPr>
            <p:spPr>
              <a:xfrm>
                <a:off x="3286397" y="1150773"/>
                <a:ext cx="1022246" cy="1492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lvl="0" indent="0" algn="l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/>
                  <a:t>ITGB6</a:t>
                </a:r>
              </a:p>
            </p:txBody>
          </p: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95BE6022-9EC3-7F43-513E-56F0986C7ABD}"/>
                  </a:ext>
                </a:extLst>
              </p:cNvPr>
              <p:cNvGrpSpPr/>
              <p:nvPr/>
            </p:nvGrpSpPr>
            <p:grpSpPr>
              <a:xfrm>
                <a:off x="3332723" y="792863"/>
                <a:ext cx="285512" cy="184700"/>
                <a:chOff x="1297702" y="856124"/>
                <a:chExt cx="285512" cy="184700"/>
              </a:xfrm>
            </p:grpSpPr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5BCA2440-09B9-2CED-ED2E-66A2F47203C5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72715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EE041BB4-9FCD-4D1D-F12C-92CA5CA0B269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/>
                    <a:t>33</a:t>
                  </a:r>
                </a:p>
              </p:txBody>
            </p:sp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42F26753-40DE-354B-91FE-4C35E1821CBB}"/>
                  </a:ext>
                </a:extLst>
              </p:cNvPr>
              <p:cNvGrpSpPr/>
              <p:nvPr/>
            </p:nvGrpSpPr>
            <p:grpSpPr>
              <a:xfrm>
                <a:off x="3828350" y="792863"/>
                <a:ext cx="285512" cy="184700"/>
                <a:chOff x="1297702" y="856124"/>
                <a:chExt cx="285512" cy="184700"/>
              </a:xfrm>
            </p:grpSpPr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7996A9C0-03A7-F096-56CB-04C3E0D36E0B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56897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BE4C839B-0FA4-7317-4581-4BDFF21AC35C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/>
                    <a:t>27</a:t>
                  </a:r>
                </a:p>
              </p:txBody>
            </p:sp>
          </p:grp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D689CBB1-F514-8822-49CD-98F6316C1969}"/>
                </a:ext>
              </a:extLst>
            </p:cNvPr>
            <p:cNvGrpSpPr/>
            <p:nvPr/>
          </p:nvGrpSpPr>
          <p:grpSpPr>
            <a:xfrm>
              <a:off x="158341" y="2105296"/>
              <a:ext cx="1751916" cy="1130237"/>
              <a:chOff x="105610" y="2427090"/>
              <a:chExt cx="2078985" cy="1397527"/>
            </a:xfrm>
          </p:grpSpPr>
          <p:pic>
            <p:nvPicPr>
              <p:cNvPr id="12" name="Picture 11" descr="A graph of a number of days&#10;&#10;AI-generated content may be incorrect.">
                <a:extLst>
                  <a:ext uri="{FF2B5EF4-FFF2-40B4-BE49-F238E27FC236}">
                    <a16:creationId xmlns:a16="http://schemas.microsoft.com/office/drawing/2014/main" id="{28D7B3AF-6414-73C6-23B4-C0891CAB8D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5610" y="2453976"/>
                <a:ext cx="2078985" cy="1370641"/>
              </a:xfrm>
              <a:prstGeom prst="rect">
                <a:avLst/>
              </a:prstGeom>
            </p:spPr>
          </p:pic>
          <p:sp>
            <p:nvSpPr>
              <p:cNvPr id="147" name="Google Shape;147;p20">
                <a:extLst>
                  <a:ext uri="{FF2B5EF4-FFF2-40B4-BE49-F238E27FC236}">
                    <a16:creationId xmlns:a16="http://schemas.microsoft.com/office/drawing/2014/main" id="{191013A2-B064-406A-B480-BCC8EA831DA1}"/>
                  </a:ext>
                </a:extLst>
              </p:cNvPr>
              <p:cNvSpPr txBox="1"/>
              <p:nvPr/>
            </p:nvSpPr>
            <p:spPr>
              <a:xfrm>
                <a:off x="1094700" y="2671278"/>
                <a:ext cx="983783" cy="14924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lvl="0" indent="0" algn="l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/>
                  <a:t>S100A14</a:t>
                </a:r>
              </a:p>
            </p:txBody>
          </p: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25469F27-64F5-DB29-4B2F-25C424498CAB}"/>
                  </a:ext>
                </a:extLst>
              </p:cNvPr>
              <p:cNvGrpSpPr/>
              <p:nvPr/>
            </p:nvGrpSpPr>
            <p:grpSpPr>
              <a:xfrm>
                <a:off x="1255092" y="2427090"/>
                <a:ext cx="285512" cy="184700"/>
                <a:chOff x="1297702" y="856124"/>
                <a:chExt cx="285512" cy="184700"/>
              </a:xfrm>
            </p:grpSpPr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468B70D6-1F92-897F-2C66-AE4D21CC9C5F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56897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528F3B82-BE29-5EAF-4D6C-A79C4EB1232E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/>
                    <a:t>31</a:t>
                  </a: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04638836-1F56-1D30-E0DD-C1FC2E2F5418}"/>
                  </a:ext>
                </a:extLst>
              </p:cNvPr>
              <p:cNvGrpSpPr/>
              <p:nvPr/>
            </p:nvGrpSpPr>
            <p:grpSpPr>
              <a:xfrm>
                <a:off x="1692716" y="2427090"/>
                <a:ext cx="285512" cy="184700"/>
                <a:chOff x="1297702" y="856124"/>
                <a:chExt cx="285512" cy="184700"/>
              </a:xfrm>
            </p:grpSpPr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B9A43FD0-C433-FAFD-A5E3-2B4645C193CA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56897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CB6F99C0-1C15-46BC-92AB-71BC1D95F4F2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/>
                    <a:t>29</a:t>
                  </a:r>
                </a:p>
              </p:txBody>
            </p:sp>
          </p:grp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E17F1822-A09B-9600-98AC-62975B509617}"/>
                </a:ext>
              </a:extLst>
            </p:cNvPr>
            <p:cNvGrpSpPr/>
            <p:nvPr/>
          </p:nvGrpSpPr>
          <p:grpSpPr>
            <a:xfrm>
              <a:off x="2023754" y="2084189"/>
              <a:ext cx="2077114" cy="1130236"/>
              <a:chOff x="2204945" y="2421818"/>
              <a:chExt cx="2469202" cy="1402797"/>
            </a:xfrm>
          </p:grpSpPr>
          <p:pic>
            <p:nvPicPr>
              <p:cNvPr id="14" name="Picture 13" descr="A graph of a number of days&#10;&#10;AI-generated content may be incorrect.">
                <a:extLst>
                  <a:ext uri="{FF2B5EF4-FFF2-40B4-BE49-F238E27FC236}">
                    <a16:creationId xmlns:a16="http://schemas.microsoft.com/office/drawing/2014/main" id="{EED8E5A8-FAEE-454A-E0D8-EC9F9A0D37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204945" y="2443430"/>
                <a:ext cx="2163651" cy="1381185"/>
              </a:xfrm>
              <a:prstGeom prst="rect">
                <a:avLst/>
              </a:prstGeom>
            </p:spPr>
          </p:pic>
          <p:sp>
            <p:nvSpPr>
              <p:cNvPr id="148" name="Google Shape;148;p20">
                <a:extLst>
                  <a:ext uri="{FF2B5EF4-FFF2-40B4-BE49-F238E27FC236}">
                    <a16:creationId xmlns:a16="http://schemas.microsoft.com/office/drawing/2014/main" id="{5D4C7D30-1A16-0A1D-8E41-5FE55D81A7DE}"/>
                  </a:ext>
                </a:extLst>
              </p:cNvPr>
              <p:cNvSpPr txBox="1"/>
              <p:nvPr/>
            </p:nvSpPr>
            <p:spPr>
              <a:xfrm>
                <a:off x="3470640" y="2694445"/>
                <a:ext cx="1203507" cy="1821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lvl="0" indent="0" algn="l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/>
                  <a:t>KRT5</a:t>
                </a:r>
              </a:p>
            </p:txBody>
          </p: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031CD283-7C59-BB1A-AE01-8EEF8F8F3445}"/>
                  </a:ext>
                </a:extLst>
              </p:cNvPr>
              <p:cNvGrpSpPr/>
              <p:nvPr/>
            </p:nvGrpSpPr>
            <p:grpSpPr>
              <a:xfrm>
                <a:off x="3406406" y="2421818"/>
                <a:ext cx="285512" cy="184700"/>
                <a:chOff x="1297702" y="856124"/>
                <a:chExt cx="285512" cy="184700"/>
              </a:xfrm>
            </p:grpSpPr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0DB79B2C-6212-98D2-B873-F3E9E81D54EC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56897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BA200586-4636-0236-FBF8-62CAEE11BE9B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 dirty="0"/>
                    <a:t>29</a:t>
                  </a:r>
                </a:p>
              </p:txBody>
            </p:sp>
          </p:grp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06BA91EB-EE69-DC9F-D58E-3E7D0748B7F9}"/>
                  </a:ext>
                </a:extLst>
              </p:cNvPr>
              <p:cNvGrpSpPr/>
              <p:nvPr/>
            </p:nvGrpSpPr>
            <p:grpSpPr>
              <a:xfrm>
                <a:off x="3875668" y="2421818"/>
                <a:ext cx="285512" cy="184700"/>
                <a:chOff x="1297702" y="856124"/>
                <a:chExt cx="285512" cy="184700"/>
              </a:xfrm>
            </p:grpSpPr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341B2D20-FBA8-1B13-4BFA-346A73CCEFC4}"/>
                    </a:ext>
                  </a:extLst>
                </p:cNvPr>
                <p:cNvSpPr/>
                <p:nvPr/>
              </p:nvSpPr>
              <p:spPr>
                <a:xfrm>
                  <a:off x="1387033" y="856124"/>
                  <a:ext cx="56897" cy="1328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59268136-83E5-84C3-D53B-001A30BDB55A}"/>
                    </a:ext>
                  </a:extLst>
                </p:cNvPr>
                <p:cNvSpPr txBox="1"/>
                <p:nvPr/>
              </p:nvSpPr>
              <p:spPr>
                <a:xfrm>
                  <a:off x="1297702" y="856158"/>
                  <a:ext cx="285512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/>
                <a:p>
                  <a:r>
                    <a:rPr lang="en-US" sz="600" dirty="0"/>
                    <a:t>31</a:t>
                  </a:r>
                </a:p>
              </p:txBody>
            </p:sp>
          </p:grpSp>
        </p:grpSp>
      </p:grpSp>
      <p:pic>
        <p:nvPicPr>
          <p:cNvPr id="19" name="Picture 18" descr="A screen shot of a chart&#10;&#10;AI-generated content may be incorrect.">
            <a:extLst>
              <a:ext uri="{FF2B5EF4-FFF2-40B4-BE49-F238E27FC236}">
                <a16:creationId xmlns:a16="http://schemas.microsoft.com/office/drawing/2014/main" id="{2CC3585C-9FB9-9274-F8CD-1796D84D0CC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7983" y="4927688"/>
            <a:ext cx="2450919" cy="291857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170FD12-73DE-F9A0-CBB0-3D82E48698D6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-279" t="30" b="-31"/>
          <a:stretch>
            <a:fillRect/>
          </a:stretch>
        </p:blipFill>
        <p:spPr>
          <a:xfrm>
            <a:off x="2657612" y="4931805"/>
            <a:ext cx="2457758" cy="2899637"/>
          </a:xfrm>
          <a:prstGeom prst="rect">
            <a:avLst/>
          </a:prstGeom>
        </p:spPr>
      </p:pic>
      <p:pic>
        <p:nvPicPr>
          <p:cNvPr id="26" name="Picture 25" descr="A diagram of a cell project&#10;&#10;AI-generated content may be incorrect.">
            <a:extLst>
              <a:ext uri="{FF2B5EF4-FFF2-40B4-BE49-F238E27FC236}">
                <a16:creationId xmlns:a16="http://schemas.microsoft.com/office/drawing/2014/main" id="{6C68B589-56B8-8E8E-B7A5-B3AC61756A0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06822" y="4927674"/>
            <a:ext cx="2461622" cy="2903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2991984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32</Words>
  <Application>Microsoft Office PowerPoint</Application>
  <PresentationFormat>Custom</PresentationFormat>
  <Paragraphs>2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Arial</vt:lpstr>
      <vt:lpstr>Simple Light</vt:lpstr>
      <vt:lpstr>PowerPoint Presentation</vt:lpstr>
      <vt:lpstr>Supplemental Figure S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Hui Zhang</dc:creator>
  <cp:lastModifiedBy>MDPI</cp:lastModifiedBy>
  <cp:revision>566</cp:revision>
  <dcterms:modified xsi:type="dcterms:W3CDTF">2026-02-19T03:24:00Z</dcterms:modified>
</cp:coreProperties>
</file>